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16200438" cy="255603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0" y="-48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4183141"/>
            <a:ext cx="13770372" cy="8898784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13425096"/>
            <a:ext cx="12150329" cy="6171163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3420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8488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1360851"/>
            <a:ext cx="3493219" cy="2166120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1360851"/>
            <a:ext cx="10277153" cy="2166120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6883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5081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6372342"/>
            <a:ext cx="13972878" cy="10632389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17105317"/>
            <a:ext cx="13972878" cy="5591322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>
                    <a:tint val="82000"/>
                  </a:schemeClr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82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82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0116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6804256"/>
            <a:ext cx="6885186" cy="1621780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6804256"/>
            <a:ext cx="6885186" cy="1621780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1447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360857"/>
            <a:ext cx="13972878" cy="494048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6265835"/>
            <a:ext cx="6853544" cy="3070789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9336623"/>
            <a:ext cx="6853544" cy="137327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6265835"/>
            <a:ext cx="6887296" cy="3070789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9336623"/>
            <a:ext cx="6887296" cy="137327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9214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6767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2429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704022"/>
            <a:ext cx="5225063" cy="5964079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3680221"/>
            <a:ext cx="8201472" cy="18164407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7668102"/>
            <a:ext cx="5225063" cy="1420610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7604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704022"/>
            <a:ext cx="5225063" cy="5964079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3680221"/>
            <a:ext cx="8201472" cy="18164407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7668102"/>
            <a:ext cx="5225063" cy="1420610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1194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1360857"/>
            <a:ext cx="13972878" cy="49404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6804256"/>
            <a:ext cx="13972878" cy="16217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23690652"/>
            <a:ext cx="3645099" cy="13608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0F810B-A08B-4398-8C27-1BC8EEE2F581}" type="datetimeFigureOut">
              <a:rPr lang="es-ES" smtClean="0"/>
              <a:t>27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23690652"/>
            <a:ext cx="5467648" cy="13608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23690652"/>
            <a:ext cx="3645099" cy="136085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D5735F-49C8-4B10-B49C-EDA991B856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7952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nsembl.org/info/data/biomart/index.html" TargetMode="External"/><Relationship Id="rId2" Type="http://schemas.openxmlformats.org/officeDocument/2006/relationships/hyperlink" Target="https://www.flyrnai.org/cgi-bin/DRSC_orthologs.pl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0FF28741-2D5C-6EFB-99D5-2B30F4E538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8508554"/>
              </p:ext>
            </p:extLst>
          </p:nvPr>
        </p:nvGraphicFramePr>
        <p:xfrm>
          <a:off x="680104" y="518247"/>
          <a:ext cx="14924210" cy="22973564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1274473">
                  <a:extLst>
                    <a:ext uri="{9D8B030D-6E8A-4147-A177-3AD203B41FA5}">
                      <a16:colId xmlns:a16="http://schemas.microsoft.com/office/drawing/2014/main" val="3205156785"/>
                    </a:ext>
                  </a:extLst>
                </a:gridCol>
                <a:gridCol w="1884073">
                  <a:extLst>
                    <a:ext uri="{9D8B030D-6E8A-4147-A177-3AD203B41FA5}">
                      <a16:colId xmlns:a16="http://schemas.microsoft.com/office/drawing/2014/main" val="3966757113"/>
                    </a:ext>
                  </a:extLst>
                </a:gridCol>
                <a:gridCol w="2822608">
                  <a:extLst>
                    <a:ext uri="{9D8B030D-6E8A-4147-A177-3AD203B41FA5}">
                      <a16:colId xmlns:a16="http://schemas.microsoft.com/office/drawing/2014/main" val="551056466"/>
                    </a:ext>
                  </a:extLst>
                </a:gridCol>
                <a:gridCol w="1718813">
                  <a:extLst>
                    <a:ext uri="{9D8B030D-6E8A-4147-A177-3AD203B41FA5}">
                      <a16:colId xmlns:a16="http://schemas.microsoft.com/office/drawing/2014/main" val="2670505590"/>
                    </a:ext>
                  </a:extLst>
                </a:gridCol>
                <a:gridCol w="2259507">
                  <a:extLst>
                    <a:ext uri="{9D8B030D-6E8A-4147-A177-3AD203B41FA5}">
                      <a16:colId xmlns:a16="http://schemas.microsoft.com/office/drawing/2014/main" val="3983851003"/>
                    </a:ext>
                  </a:extLst>
                </a:gridCol>
                <a:gridCol w="3088601">
                  <a:extLst>
                    <a:ext uri="{9D8B030D-6E8A-4147-A177-3AD203B41FA5}">
                      <a16:colId xmlns:a16="http://schemas.microsoft.com/office/drawing/2014/main" val="1876190260"/>
                    </a:ext>
                  </a:extLst>
                </a:gridCol>
                <a:gridCol w="1876135">
                  <a:extLst>
                    <a:ext uri="{9D8B030D-6E8A-4147-A177-3AD203B41FA5}">
                      <a16:colId xmlns:a16="http://schemas.microsoft.com/office/drawing/2014/main" val="3280974305"/>
                    </a:ext>
                  </a:extLst>
                </a:gridCol>
              </a:tblGrid>
              <a:tr h="40855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Sopathy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Human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Sopathy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gene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Danio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erio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%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identity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Drosophila: %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identity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C.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Elegan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%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identity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Xenopu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tropicali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%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identity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Gallu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gallu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%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identity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28537654"/>
                  </a:ext>
                </a:extLst>
              </a:tr>
              <a:tr h="33477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NF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NF1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nf1b: 85; nf1a: 83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Nf1: 54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gap-1: 20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nf1: 90; rasa2: 20; rasa4: 21; tgm4: 19 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nf1: 9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2394989"/>
                  </a:ext>
                </a:extLst>
              </a:tr>
              <a:tr h="53243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LS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PRED1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pred1: 54; spred2b: 50; spred2a: 46; spred3: 3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pred: 30; ena: 32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unc-34: 24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pred1: 64; spred3: 43; spred2: 48; spry4: 2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pred1 7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2632385"/>
                  </a:ext>
                </a:extLst>
              </a:tr>
              <a:tr h="52111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N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TPN11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tpn11a: 90; ptpn11b: 68; ptpn6: 5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csw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0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tp-2: 36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tpn11: 93; ptpn11b: 66; ptpn6: 53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tpn11: 9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19610218"/>
                  </a:ext>
                </a:extLst>
              </a:tr>
              <a:tr h="84495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1: 44; sos2: 64; rasgrf2b: 19; si:ch211-234p18.3: 19; rapgef1b: 20; rapgef1a: 2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PDZ-GEF: 17; C3G: 22; CG5522: 25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-1: 30; pxf-1: 19; Y34B4A.4: 2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1: 88; sos2: 69; rapgef6: 19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1: 89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2012803"/>
                  </a:ext>
                </a:extLst>
              </a:tr>
              <a:tr h="112249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IT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it1: 78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Ric: 55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W04C9.5: 20; let-60: 48; ral-1: 40; ras-2: 40; ras-1: 43; Y71F9AR.2: 25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it1: 89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erg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4 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2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2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ras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4; LOC100488596: 28; kras: 49; rasl11b: 30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erg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3; rasd1: 38; rab39a: 31; cdc42: 27; rac3: 32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it1: 9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000348"/>
                  </a:ext>
                </a:extLst>
              </a:tr>
              <a:tr h="60188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F1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f1b: 75; raf1a: 7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9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sr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in-45: 39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f1: 8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; irak4: 24; acvr2b: 25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f1: 9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5491930"/>
                  </a:ext>
                </a:extLst>
              </a:tr>
              <a:tr h="112274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: 9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5558: 8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5; rras2: 54; 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5; 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 rap1ab: 56;  rap1b: 54;  rap1aa: 55;  si:ch73-1160132: 5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2      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Ras85D: 77; Ras64B: 54; Rap1: 53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et-60: 74; ras-1: 50; rap-1: 53; ras-2: 4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ras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97; kras: 8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rap1a: 54; rap1b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8; rab2b: 36; rap2a: 50; rap2c: 48; rasd1: 3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: 9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95953579"/>
                  </a:ext>
                </a:extLst>
              </a:tr>
              <a:tr h="77550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mras: 85; si:ch73-116o1.2: 88; kras: 50; hrasa: 50; zgc:55558: 51; rras: 54; nras: 50; hrasb: 51; rras2: 58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64B: 58; Ras85D: 5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ras-2: 56; let-60: 55; ras-1: 52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mras: 92; rras: 53; kras: 53; krasl: 44; cdc42: 29; rac3: 33; rerg: 32; rasd1: 30 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8458575"/>
                  </a:ext>
                </a:extLst>
              </a:tr>
              <a:tr h="8888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1; kras: 8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8; zgc:55558: 8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8; rras2: 53; si:ch73-116o1.2: 52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1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85D: 80; Ras64B: 5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let-60: 76; ras-1: 56; ras-2: 50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nras: 92; kras: 91; krasl: 87; hras: 86; rras: 53; rap1a: 56; rap1b: 57; rap2a: 49; rerg: 32; rap2c: 49; rasd1: 34 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39300104"/>
                  </a:ext>
                </a:extLst>
              </a:tr>
              <a:tr h="111110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RAS2*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71; kras: 52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3; zgc:55558: 60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rras2: 68; rap1ab: 48; rap1b: 49; rap1aa: 48; si:ch73-116o1.2: 5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1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64B: 64; Ras85D: 57; Rap1: 49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-1: 68; let-60: 56; rap-1: 47; ras-2: 51; rap-3: 4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74; kras: 5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ras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rap1a: 48; rap1b: 49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3; rras2: 70; rap2a: 49; rap2c: 43; rasd1: 34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 9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20113296"/>
                  </a:ext>
                </a:extLst>
              </a:tr>
              <a:tr h="133333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RAS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ras2: 96; kras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zgc:55558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7; zgc:55558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rap1ab: 50; rap1b: 51; rap1aa: 49; si:ch73-116o1.2: 58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64B: 71; Ras85D: 57; Rap1: 50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-1: 62; let-60: 56; rap-1: 50; ras-2: 5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ras2: 9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76; kras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ras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rap1a: 48; rap1b: 51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cdc42: 30; rac3: 30; rap2a: 48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erg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5; rap2c: 45; rasd1: 3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ras2: 9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6343726"/>
                  </a:ext>
                </a:extLst>
              </a:tr>
              <a:tr h="76411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HOC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hoc2: 88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ur-8: 58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c-2: 5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spn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podn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8; firt1: 24; phlpp1: 27; mfhas1: 29; lrrc47: 26; LOC100485206: 28; lrrc2: 20; lrrc8a: 28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hoc2: 95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7420485"/>
                  </a:ext>
                </a:extLst>
              </a:tr>
              <a:tr h="7407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2*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2: 35; sis1: 35; rasgrf2b: 19; si:ch211-234p18.3: 19; rapgef1b: 21; rapgef1a: 2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os: 43; C3G: 23; CG5522: 22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-1: 30; Y34B4A.4: 2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2: 84; sos1: 67; cldnd1: 23; rapgef6: 17; LOC100487632: 32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os2: 8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50765607"/>
                  </a:ext>
                </a:extLst>
              </a:tr>
              <a:tr h="57873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PRED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pred2b: 69; spred2a: 65; spred1: 52; spred3: 38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pred: 33; ena: 28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unc-34: 24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pred2: 75 ; spred3: 46; spred1: 52 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pred2: 8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39482863"/>
                  </a:ext>
                </a:extLst>
              </a:tr>
              <a:tr h="56715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ZTR1*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ztr1: 8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ztr1: 51; CG12081: 26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F53E4.1 : 24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ztr1: 81; hcfc1: 2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bepk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6; klhdc2: 29; klhdc10: 23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ztr1: 8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2148829"/>
                  </a:ext>
                </a:extLst>
              </a:tr>
              <a:tr h="2164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A2ML1*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:dkey-46g23,5: 35; a2ml: 3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165453: 3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171446: 36; si:ch211-212c13,10: 36; si: dkey-105h12,2: 3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165518: 3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171445: 3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z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171426: 35;  LOC100006895: 37; LOC10390927: 36; LOC108179231: 38; LOC407643: 40; LOC101886227: 32; si:dkey-52d15.2: 35; c4b: 23; cd109: 25; LOC569025: 37; c4: 22; c5: 20; c3b1: 24; c3a.4: 24; c3b.2: 2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Tep4: 25; Tep2: 27; Tep1: 25; Tep3: 23; Tep5: 20; Mcr: 20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tep-1: 27; F13D2.1: 1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pzp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2; LOC619594: 42; a2ml1: 43; a2m: 38; map4k5: 18; gpr37: 20; LOC100487578: 38; acap2: 20; LOC101730963: 38; LOC101734901: 42; LOC100495827: 39; ovos2: 33; LOC100170611: 24; cpamd8: 25; c5: 2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ptcd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3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18509354"/>
                  </a:ext>
                </a:extLst>
              </a:tr>
              <a:tr h="55558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BRAF*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; raf1b: 5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Raf: 43; ksr: 26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in-45: 3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braf: 86; araf: 53; raf1: 53; tec: 22; tgfbr2: 24; acvr2b: 25; rxfp3: 20 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2605394"/>
                  </a:ext>
                </a:extLst>
              </a:tr>
              <a:tr h="111110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C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4 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4; kras: 86; zgc:55558: 89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4; rras2: 5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4; rap1ab: 53; rap1aa: 53; rap1b: 57; si:ch73-11601,2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9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s85D: 78; Ras64B: 56; Rap1: 5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et-60: 76; ras-1: 53; rap-1: 53; ras-2: 5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6; kras: 8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ras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8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; rap1a: 54; rap1b: 5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4; rap2a: 46; rap2c: 45; rasd1: 33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02076212"/>
                  </a:ext>
                </a:extLst>
              </a:tr>
              <a:tr h="55564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CFCS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; raf1b: 5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ksr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6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lin-45: 28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a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3; raf1: 5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te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2; tgfbr2: 24; acvr2b: 25; rxfp3: 20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bra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9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90893802"/>
                  </a:ext>
                </a:extLst>
              </a:tr>
              <a:tr h="155555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EK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2k1: 88; map2k2a:80; map2k2b: 78; map2k5: 38; map2k6: 34; map2k4a: 33; stk39: 25; map2k4b: 34; map2k7:33; stk25a:31; map3k10: 24; zak:2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slk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1; stk24b:33; mast2: 26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slk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0; stk24a: 29; map3k21:2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Dsor1: 63; lic: 33; Mkk4: 34; hep: 32; Slik: 30; hpo: 34; GckIII: 34; hppy: 31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ek-2: 53; mkk-4: 30; sek-1: 36; E02D9.3: 25; sek-5: 29; jkk-1: 29; sek-3: 32; sek-6: 31; mek-1: 32; cst-2: 32; nekl-3: 26; nsy-1: 26; cst-1: 3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2k1: 92; map2k5: 38; map2k6: 37; myof.1: 22; stk39: 25; macroh2a1: 22; map2k4: 34; map2k7: 33; map4k3: 29; map3k10: 23; stk3: 35; stk4: 3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K1: 9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14105343"/>
                  </a:ext>
                </a:extLst>
              </a:tr>
              <a:tr h="111110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EK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2k2a: 86; map2k2b: 82; map2k1: 80; map2k5:40; map2k6:33; map2k4a:35; map2k4b: 35; map2k7: 31; si:dkey-81j8.6: 29; stk26: 32; stk3: 31; stk24a: 30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Dsor1: 54; lic: 32; Mkk4: 33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ek-2: 53; sek-1: 34; mkk-4: 33; sek-6: 40; jkk-1:33; sek-3:32; mek-1: 33; sek-5: 30; gck-1: 28; cst-1: 25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2k1: 80; map2k5: 35; map2k6: 35; myof.1: 22; stk39: 27; stk3: 30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MAPK2: 9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72593658"/>
                  </a:ext>
                </a:extLst>
              </a:tr>
              <a:tr h="102566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kras: 93; hrasa: 85; zgc 5558: 84; hrasb: 85; rras2: 54;  nras: 85;  rras: 54;  rap1ab: 56;  rap1b: 54;  rap1aa: 55;  si:ch73-1160132: 57; mras: 52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Ras85D: 77; Ras64B: 54; Rap1: 53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let-60: 74; ras-1: 50; rap-1: 53; ras-2: 47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: 8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h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5; rap1a: 57; rap1b: 5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nras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88; rab2b: 36; rap2a: 50; rap2c: 48; rasd1: 31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kras: 98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6928490"/>
                  </a:ext>
                </a:extLst>
              </a:tr>
              <a:tr h="86810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E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YNGAP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>
                          <a:effectLst/>
                          <a:latin typeface="Palatino Linotype" panose="02040502050505030304" pitchFamily="18" charset="0"/>
                        </a:rPr>
                        <a:t>syngap1b: 55; syngap1a: 60; dab2ipb: 48; dab2ipa: 48; rasal3: 38; rasa1b: 26; rasa1a: 23</a:t>
                      </a:r>
                      <a:endParaRPr lang="es-ES" sz="1400" kern="10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CG42684: 28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vap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24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gap-2: 33 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syngap1: 73; rasal2: 46; rasal3: 34; dab2ip: 48; rasal1: 24; rasa1: 23; rasa4: 2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14802015"/>
                  </a:ext>
                </a:extLst>
              </a:tr>
              <a:tr h="177777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ASopathy-like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1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1a: 89; rac1b: 89; rac1l: 64; rac3b: 86; LOC100537765: 87; rac3a: 87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gc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v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5; cdc42l: 6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g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0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gd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g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2; si:ch211-133l11.10: 49; cdc42: 6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ua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2; cdc42l2: 50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ub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0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q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8; rac2: 83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h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38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f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j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9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1: 83; Rac2: 81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Mtl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5; Cdc42: 6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U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2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-2: 68; ced-10: 75; mig-2: 61; crp-1: 41; cdc-42: 63; chw-1: 4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1: 90; rac3: 85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g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64; rhog2: 65; rac2: 83; cdc42: 64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v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1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j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56; dynlt5: 19; </a:t>
                      </a:r>
                      <a:r>
                        <a:rPr lang="es-ES" sz="1050" kern="0" dirty="0" err="1">
                          <a:effectLst/>
                          <a:latin typeface="Palatino Linotype" panose="02040502050505030304" pitchFamily="18" charset="0"/>
                        </a:rPr>
                        <a:t>rhoh</a:t>
                      </a: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: 41; rhobtb2: 37; pias1: 23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s-ES" sz="1050" kern="0" dirty="0">
                          <a:effectLst/>
                          <a:latin typeface="Palatino Linotype" panose="02040502050505030304" pitchFamily="18" charset="0"/>
                        </a:rPr>
                        <a:t>rac1: 100</a:t>
                      </a:r>
                      <a:endParaRPr lang="es-ES" sz="1400" kern="100" dirty="0">
                        <a:effectLst/>
                        <a:latin typeface="Palatino Linotype" panose="0204050205050503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4624" marR="54624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48642864"/>
                  </a:ext>
                </a:extLst>
              </a:tr>
            </a:tbl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FF0AB4C4-2689-55B0-C617-603656A44568}"/>
              </a:ext>
            </a:extLst>
          </p:cNvPr>
          <p:cNvSpPr txBox="1"/>
          <p:nvPr/>
        </p:nvSpPr>
        <p:spPr>
          <a:xfrm>
            <a:off x="545108" y="23953259"/>
            <a:ext cx="15110219" cy="9308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983"/>
              </a:spcAft>
            </a:pPr>
            <a:r>
              <a:rPr lang="en-GB" sz="1200" b="1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1.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nservatio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f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Sopathy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enes in non-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mmali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del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ganism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s-ES" sz="1200" b="1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i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able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llustrate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ercentag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f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dentity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etwee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enes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ssociat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Sopathie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ir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tholog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n non-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mmali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del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ocusing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clusively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os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enes and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del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ention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n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ext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In genes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ssociat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oon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yndrom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NS),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sterisk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re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us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o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dicat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dditional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nnectio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oon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yndrom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ultipl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entigine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NSML,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enot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y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*)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yndromes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esembling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oona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yndrom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**). Data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ave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een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btained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rom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DIOPT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tholog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inder (</a:t>
            </a:r>
            <a:r>
              <a:rPr lang="es-ES" sz="1200" u="sng" kern="100" dirty="0">
                <a:solidFill>
                  <a:srgbClr val="0000FF"/>
                </a:solidFill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2"/>
              </a:rPr>
              <a:t>https://www.flyrnai.org/cgi-bin/DRSC_orthologs.pl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nsembl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Bio </a:t>
            </a:r>
            <a:r>
              <a:rPr lang="es-ES" sz="1200" kern="100" dirty="0" err="1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art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</a:t>
            </a:r>
            <a:r>
              <a:rPr lang="es-ES" sz="1200" u="sng" kern="100" dirty="0">
                <a:solidFill>
                  <a:srgbClr val="0000FF"/>
                </a:solidFill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3"/>
              </a:rPr>
              <a:t>https://www.ensembl.org/info/data/biomart/index.html</a:t>
            </a:r>
            <a:r>
              <a:rPr lang="es-ES" sz="1200" kern="100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.</a:t>
            </a:r>
            <a:endParaRPr lang="es-ES" sz="16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39252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2400</Words>
  <Application>Microsoft Office PowerPoint</Application>
  <PresentationFormat>Personalizado</PresentationFormat>
  <Paragraphs>17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o.rm@usal.es</dc:creator>
  <cp:lastModifiedBy>mario.rm@usal.es</cp:lastModifiedBy>
  <cp:revision>2</cp:revision>
  <dcterms:created xsi:type="dcterms:W3CDTF">2024-02-27T10:52:12Z</dcterms:created>
  <dcterms:modified xsi:type="dcterms:W3CDTF">2024-02-27T11:32:43Z</dcterms:modified>
</cp:coreProperties>
</file>